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EB678-EC1F-450C-A67A-959B6C44A6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9787F-99CF-43EB-BDB1-CBE9BCB644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891DB-6E83-4A45-8598-0C205AC4AF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3B67B2-7497-43F5-A2C8-72C909A69C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6EC10-3ACF-4E6C-B692-C57C8D6EDF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D77C4-DB03-497B-8249-CB74A8C2D5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FFDD8-45E9-4B61-B9B1-F1F7C2C9F2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13182-526E-4438-9083-F98E97D9C5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4B154-D0B6-4398-8301-01FA8307A7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FBB16-478D-495E-B752-DE84AECF05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9407E-33F5-4686-B01B-ADB8F28FD1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41C7F-4CA1-40E9-B135-19CE6680D4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BB3276-3F8E-4A67-8A0B-66416DB3A560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17 Grupo"/>
          <p:cNvGrpSpPr/>
          <p:nvPr/>
        </p:nvGrpSpPr>
        <p:grpSpPr>
          <a:xfrm>
            <a:off x="264960" y="404640"/>
            <a:ext cx="2578320" cy="2169360"/>
            <a:chOff x="264960" y="404640"/>
            <a:chExt cx="2578320" cy="2169360"/>
          </a:xfrm>
        </p:grpSpPr>
        <p:pic>
          <p:nvPicPr>
            <p:cNvPr id="42" name="Picture 19" descr=""/>
            <p:cNvPicPr/>
            <p:nvPr/>
          </p:nvPicPr>
          <p:blipFill>
            <a:blip r:embed="rId1"/>
            <a:stretch/>
          </p:blipFill>
          <p:spPr>
            <a:xfrm>
              <a:off x="395280" y="404640"/>
              <a:ext cx="2448000" cy="1959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47 CuadroTexto"/>
            <p:cNvSpPr/>
            <p:nvPr/>
          </p:nvSpPr>
          <p:spPr>
            <a:xfrm>
              <a:off x="902160" y="2205720"/>
              <a:ext cx="1814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Baseline level of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CD8+CD38-HLADR-PD1+Tim3+cell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47 CuadroTexto"/>
            <p:cNvSpPr/>
            <p:nvPr/>
          </p:nvSpPr>
          <p:spPr>
            <a:xfrm rot="16200000">
              <a:off x="-245880" y="1202760"/>
              <a:ext cx="1390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CD4 slope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(% of baseline CD4 count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" name="18 Grupo"/>
          <p:cNvGrpSpPr/>
          <p:nvPr/>
        </p:nvGrpSpPr>
        <p:grpSpPr>
          <a:xfrm>
            <a:off x="3314880" y="404640"/>
            <a:ext cx="2481120" cy="2070720"/>
            <a:chOff x="3314880" y="404640"/>
            <a:chExt cx="2481120" cy="2070720"/>
          </a:xfrm>
        </p:grpSpPr>
        <p:pic>
          <p:nvPicPr>
            <p:cNvPr id="46" name="Picture 3" descr=""/>
            <p:cNvPicPr/>
            <p:nvPr/>
          </p:nvPicPr>
          <p:blipFill>
            <a:blip r:embed="rId2"/>
            <a:stretch/>
          </p:blipFill>
          <p:spPr>
            <a:xfrm>
              <a:off x="3375720" y="404640"/>
              <a:ext cx="2420280" cy="194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47 CuadroTexto"/>
            <p:cNvSpPr/>
            <p:nvPr/>
          </p:nvSpPr>
          <p:spPr>
            <a:xfrm rot="16200000">
              <a:off x="3028320" y="1159200"/>
              <a:ext cx="80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900" spc="-1" strike="noStrike">
                  <a:solidFill>
                    <a:srgbClr val="000000"/>
                  </a:solidFill>
                  <a:latin typeface="Calibri"/>
                </a:rPr>
                <a:t>Δ</a:t>
              </a: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 CD4 count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47 CuadroTexto"/>
            <p:cNvSpPr/>
            <p:nvPr/>
          </p:nvSpPr>
          <p:spPr>
            <a:xfrm>
              <a:off x="4037760" y="2244240"/>
              <a:ext cx="1393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900" spc="-1" strike="noStrike">
                  <a:solidFill>
                    <a:srgbClr val="000000"/>
                  </a:solidFill>
                  <a:latin typeface="Calibri"/>
                </a:rPr>
                <a:t>Δ</a:t>
              </a: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LT CD8+PD1+Tim3+ cell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19 Grupo"/>
          <p:cNvGrpSpPr/>
          <p:nvPr/>
        </p:nvGrpSpPr>
        <p:grpSpPr>
          <a:xfrm>
            <a:off x="6172200" y="404640"/>
            <a:ext cx="2503440" cy="2075400"/>
            <a:chOff x="6172200" y="404640"/>
            <a:chExt cx="2503440" cy="2075400"/>
          </a:xfrm>
        </p:grpSpPr>
        <p:pic>
          <p:nvPicPr>
            <p:cNvPr id="50" name="Picture 4" descr=""/>
            <p:cNvPicPr/>
            <p:nvPr/>
          </p:nvPicPr>
          <p:blipFill>
            <a:blip r:embed="rId3"/>
            <a:stretch/>
          </p:blipFill>
          <p:spPr>
            <a:xfrm>
              <a:off x="6246720" y="404640"/>
              <a:ext cx="2428920" cy="194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47 CuadroTexto"/>
            <p:cNvSpPr/>
            <p:nvPr/>
          </p:nvSpPr>
          <p:spPr>
            <a:xfrm rot="16200000">
              <a:off x="5885640" y="1163520"/>
              <a:ext cx="80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900" spc="-1" strike="noStrike">
                  <a:solidFill>
                    <a:srgbClr val="000000"/>
                  </a:solidFill>
                  <a:latin typeface="Calibri"/>
                </a:rPr>
                <a:t>Δ</a:t>
              </a: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 CD4 count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47 CuadroTexto"/>
            <p:cNvSpPr/>
            <p:nvPr/>
          </p:nvSpPr>
          <p:spPr>
            <a:xfrm>
              <a:off x="7030080" y="2248920"/>
              <a:ext cx="1160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900" spc="-1" strike="noStrike">
                  <a:solidFill>
                    <a:srgbClr val="000000"/>
                  </a:solidFill>
                  <a:latin typeface="Calibri"/>
                </a:rPr>
                <a:t>Δ</a:t>
              </a:r>
              <a:r>
                <a:rPr b="1" lang="es-ES" sz="900" spc="-1" strike="noStrike">
                  <a:solidFill>
                    <a:srgbClr val="000000"/>
                  </a:solidFill>
                  <a:latin typeface="Calibri"/>
                </a:rPr>
                <a:t>LT CD4+CD95+ cell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13 CuadroTexto"/>
          <p:cNvSpPr/>
          <p:nvPr/>
        </p:nvSpPr>
        <p:spPr>
          <a:xfrm>
            <a:off x="2200680" y="47628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 </a:t>
            </a:r>
            <a:r>
              <a:rPr b="1" lang="es-E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= -0.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= 0.0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14 CuadroTexto"/>
          <p:cNvSpPr/>
          <p:nvPr/>
        </p:nvSpPr>
        <p:spPr>
          <a:xfrm>
            <a:off x="5174280" y="476280"/>
            <a:ext cx="549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σ</a:t>
            </a:r>
            <a:r>
              <a:rPr b="1" lang="es-E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s-E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= -0.7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= 0.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15 CuadroTexto"/>
          <p:cNvSpPr/>
          <p:nvPr/>
        </p:nvSpPr>
        <p:spPr>
          <a:xfrm>
            <a:off x="8054280" y="476280"/>
            <a:ext cx="549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σ</a:t>
            </a:r>
            <a:r>
              <a:rPr b="1" lang="es-E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s-E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= -0.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p= 0.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16 CuadroTexto"/>
          <p:cNvSpPr/>
          <p:nvPr/>
        </p:nvSpPr>
        <p:spPr>
          <a:xfrm>
            <a:off x="611280" y="2708280"/>
            <a:ext cx="8064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4 Figur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Scatter-plot graphs showing the association between variation of CD4 counts (CD4 slope or Δ CD4 counts) and baseline levels of immune parameters or variation of immune parameters after long-term follow up (ΔLT) in patients on cART. Pearson correlation (r) or Spearman Rho (σ) coefficients and p-values are shown in each scatter plo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11T15:50:02Z</dcterms:created>
  <dc:creator>jose benito</dc:creator>
  <dc:description/>
  <dc:language>en-US</dc:language>
  <cp:lastModifiedBy>jose benito</cp:lastModifiedBy>
  <dcterms:modified xsi:type="dcterms:W3CDTF">2018-01-12T12:55:27Z</dcterms:modified>
  <cp:revision>11</cp:revision>
  <dc:subject/>
  <dc:title>Diapositiva 1</dc:title>
</cp:coreProperties>
</file>